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890" y="-7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EB392D-8377-4199-8CC4-4136943A24BA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D401D-FDA6-4073-A539-958DE5D490E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4"/>
          <p:cNvGrpSpPr>
            <a:grpSpLocks/>
          </p:cNvGrpSpPr>
          <p:nvPr/>
        </p:nvGrpSpPr>
        <p:grpSpPr bwMode="auto">
          <a:xfrm>
            <a:off x="-242888" y="658813"/>
            <a:ext cx="7273926" cy="6381750"/>
            <a:chOff x="-63" y="119"/>
            <a:chExt cx="4582" cy="4020"/>
          </a:xfrm>
        </p:grpSpPr>
        <p:sp>
          <p:nvSpPr>
            <p:cNvPr id="9220" name="Rectangle 5"/>
            <p:cNvSpPr>
              <a:spLocks noChangeArrowheads="1"/>
            </p:cNvSpPr>
            <p:nvPr/>
          </p:nvSpPr>
          <p:spPr bwMode="auto">
            <a:xfrm>
              <a:off x="-63" y="119"/>
              <a:ext cx="4582" cy="40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		      	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-72			                          cacttccaccatc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-59 	cctccgaaagacaaccactgcagtctctcaaaatagaattaactgcacttaaaataatc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 </a:t>
              </a:r>
              <a:r>
                <a:rPr lang="en-US" altLang="zh-TW" sz="1200" b="1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M   S   L   T   V   V   F   R   A   L   V   I   L   A   I</a:t>
              </a: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 +15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  1	</a:t>
              </a:r>
              <a:r>
                <a:rPr lang="en-US" altLang="zh-TW" sz="1200" b="1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ATG TCT TTG ACG GTG GTT TTC AGA GCT TTG GTC ATC CTT GCT ATC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 </a:t>
              </a:r>
              <a:r>
                <a:rPr lang="en-US" altLang="zh-TW" sz="1200" b="1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F   I   E   L   S   C   C</a:t>
              </a: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S   S   L   P   A   R   N   K	 +30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 46	</a:t>
              </a:r>
              <a:r>
                <a:rPr lang="en-US" altLang="zh-TW" sz="1200" b="1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TTC ATT GAG TTA TCA TGT TGC</a:t>
              </a: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TCT TCT CTT CCT GCC AGG AAT AAA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 R   </a:t>
              </a:r>
              <a:r>
                <a:rPr lang="en-US" altLang="zh-TW" sz="1200" u="sng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H   V   D   G   M   F   T   S   E   F   S   R   A   R</a:t>
              </a: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 +45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 91	AGA CAT GTT GAT GGC ATG TTT ACC AGT GAG TTC AGC CGG GCC AGA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 </a:t>
              </a:r>
              <a:r>
                <a:rPr lang="en-US" altLang="zh-TW" sz="1200" u="sng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G   S   A   A   I   R   K   I   I   N   S   A   L   A</a:t>
              </a: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G   +60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136	GGG TCA GCA GCC ATT CGA AAG ATC ATT AAC TCC GCA CTG GCT GGG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 K   R   D   L   E   E   S   S   Y   Q   T   G   P   Q   E   +75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181	AAA AGA GAT CTG GAG GAG AGC AGT TAC CAA ACT GGC CCG CAA GAA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 E   S   A   K   K   E   L   P   G   Q   A   D   Y   T   F   +90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226	GAA TCG GCC AAG AAA GAA CTG CCT GGA CAA GCT GAC TAC ACC TTC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 S   E   L   R   L   D   D   Q   D   L   H   D   V   P   Q   +105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271	TCA GAA CTG AGG TTG GAT GAT CAG GAT CTG CAT GAT GTT CCT CAA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 S   Q   L   C   S   A   I   L   N   L   L   S   R   M   P   +120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316	AGC CAG CTT TGC TCT GCC ATC TTG AAT CTG CTT AGT AGG ATG CCC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		 I   Q   S   P   Q   L   R   N   T   Q   D   Y   *           +132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361	ATT CAG TCC CCA CAA CTG CGC AAT ACA CAG GAT TAC TAAtggatcac        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408	acacaagcctggaagatgcctgctacaagcaaaccccaggaatactatactcacctaca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467	actacactgtctgcaatgatttaaagtattgagttacccattaatggcaccagaagaca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526	gaatatatatttattttatttgctttaaatgtcccataggcctgaatatgtgcaatata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585	tattattatagtttgttcatagactttgtggaaggatggctattcttaatatatcacag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r>
                <a:rPr lang="en-US" altLang="zh-TW" sz="1200">
                  <a:latin typeface="Courier New" pitchFamily="49" charset="0"/>
                  <a:ea typeface="新細明體" pitchFamily="18" charset="-120"/>
                  <a:cs typeface="Courier New" pitchFamily="49" charset="0"/>
                </a:rPr>
                <a:t>   644	caataaagcctatatatgctacagtaccaaaaaaaaaaaaaaaaaaaa	 </a:t>
              </a:r>
            </a:p>
            <a:p>
              <a:pPr marL="342900" indent="-342900">
                <a:lnSpc>
                  <a:spcPct val="80000"/>
                </a:lnSpc>
                <a:spcBef>
                  <a:spcPct val="20000"/>
                </a:spcBef>
              </a:pPr>
              <a:endParaRPr lang="zh-TW" altLang="en-US" sz="1200">
                <a:latin typeface="Courier New" pitchFamily="49" charset="0"/>
                <a:ea typeface="新細明體" pitchFamily="18" charset="-120"/>
                <a:cs typeface="Courier New" pitchFamily="49" charset="0"/>
              </a:endParaRPr>
            </a:p>
          </p:txBody>
        </p:sp>
        <p:grpSp>
          <p:nvGrpSpPr>
            <p:cNvPr id="3" name="Group 6"/>
            <p:cNvGrpSpPr>
              <a:grpSpLocks/>
            </p:cNvGrpSpPr>
            <p:nvPr/>
          </p:nvGrpSpPr>
          <p:grpSpPr bwMode="auto">
            <a:xfrm>
              <a:off x="3818" y="1480"/>
              <a:ext cx="174" cy="272"/>
              <a:chOff x="3891" y="1480"/>
              <a:chExt cx="182" cy="272"/>
            </a:xfrm>
          </p:grpSpPr>
          <p:sp>
            <p:nvSpPr>
              <p:cNvPr id="9226" name="Line 7"/>
              <p:cNvSpPr>
                <a:spLocks noChangeShapeType="1"/>
              </p:cNvSpPr>
              <p:nvPr/>
            </p:nvSpPr>
            <p:spPr bwMode="auto">
              <a:xfrm flipH="1">
                <a:off x="3891" y="1480"/>
                <a:ext cx="18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27" name="Line 8"/>
              <p:cNvSpPr>
                <a:spLocks noChangeShapeType="1"/>
              </p:cNvSpPr>
              <p:nvPr/>
            </p:nvSpPr>
            <p:spPr bwMode="auto">
              <a:xfrm>
                <a:off x="3891" y="1480"/>
                <a:ext cx="0" cy="27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28" name="Line 9"/>
              <p:cNvSpPr>
                <a:spLocks noChangeShapeType="1"/>
              </p:cNvSpPr>
              <p:nvPr/>
            </p:nvSpPr>
            <p:spPr bwMode="auto">
              <a:xfrm flipH="1">
                <a:off x="3891" y="1752"/>
                <a:ext cx="18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4" name="Group 10"/>
            <p:cNvGrpSpPr>
              <a:grpSpLocks/>
            </p:cNvGrpSpPr>
            <p:nvPr/>
          </p:nvGrpSpPr>
          <p:grpSpPr bwMode="auto">
            <a:xfrm rot="10800000">
              <a:off x="562" y="1843"/>
              <a:ext cx="417" cy="272"/>
              <a:chOff x="3878" y="1480"/>
              <a:chExt cx="188" cy="272"/>
            </a:xfrm>
          </p:grpSpPr>
          <p:sp>
            <p:nvSpPr>
              <p:cNvPr id="9223" name="Line 11"/>
              <p:cNvSpPr>
                <a:spLocks noChangeShapeType="1"/>
              </p:cNvSpPr>
              <p:nvPr/>
            </p:nvSpPr>
            <p:spPr bwMode="auto">
              <a:xfrm flipH="1">
                <a:off x="3878" y="1480"/>
                <a:ext cx="18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24" name="Line 12"/>
              <p:cNvSpPr>
                <a:spLocks noChangeShapeType="1"/>
              </p:cNvSpPr>
              <p:nvPr/>
            </p:nvSpPr>
            <p:spPr bwMode="auto">
              <a:xfrm>
                <a:off x="3880" y="1480"/>
                <a:ext cx="0" cy="27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25" name="Line 13"/>
              <p:cNvSpPr>
                <a:spLocks noChangeShapeType="1"/>
              </p:cNvSpPr>
              <p:nvPr/>
            </p:nvSpPr>
            <p:spPr bwMode="auto">
              <a:xfrm flipH="1">
                <a:off x="3884" y="1752"/>
                <a:ext cx="18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A4 Paper (210x297 mm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nice</dc:creator>
  <cp:lastModifiedBy>Janice</cp:lastModifiedBy>
  <cp:revision>1</cp:revision>
  <dcterms:created xsi:type="dcterms:W3CDTF">2011-04-07T14:19:39Z</dcterms:created>
  <dcterms:modified xsi:type="dcterms:W3CDTF">2011-04-07T14:20:10Z</dcterms:modified>
</cp:coreProperties>
</file>